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97675" cy="98567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21F08-058E-4DBA-B189-7F7A72DA0F22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ED3D7-54EA-49CA-A778-CF6FAFFDEBA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1043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21F08-058E-4DBA-B189-7F7A72DA0F22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ED3D7-54EA-49CA-A778-CF6FAFFDEBA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93417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21F08-058E-4DBA-B189-7F7A72DA0F22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ED3D7-54EA-49CA-A778-CF6FAFFDEBA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6441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21F08-058E-4DBA-B189-7F7A72DA0F22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ED3D7-54EA-49CA-A778-CF6FAFFDEBA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73877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21F08-058E-4DBA-B189-7F7A72DA0F22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ED3D7-54EA-49CA-A778-CF6FAFFDEBA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17228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21F08-058E-4DBA-B189-7F7A72DA0F22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ED3D7-54EA-49CA-A778-CF6FAFFDEBA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65622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21F08-058E-4DBA-B189-7F7A72DA0F22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ED3D7-54EA-49CA-A778-CF6FAFFDEBA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9253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21F08-058E-4DBA-B189-7F7A72DA0F22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ED3D7-54EA-49CA-A778-CF6FAFFDEBA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96877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21F08-058E-4DBA-B189-7F7A72DA0F22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ED3D7-54EA-49CA-A778-CF6FAFFDEBA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91723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21F08-058E-4DBA-B189-7F7A72DA0F22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ED3D7-54EA-49CA-A778-CF6FAFFDEBA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26377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21F08-058E-4DBA-B189-7F7A72DA0F22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0ED3D7-54EA-49CA-A778-CF6FAFFDEBA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83914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121F08-058E-4DBA-B189-7F7A72DA0F22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0ED3D7-54EA-49CA-A778-CF6FAFFDEBAD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3666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7627"/>
          <a:stretch/>
        </p:blipFill>
        <p:spPr bwMode="auto">
          <a:xfrm>
            <a:off x="5220072" y="456804"/>
            <a:ext cx="3240405" cy="22521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feld 4">
            <a:extLst>
              <a:ext uri="{FF2B5EF4-FFF2-40B4-BE49-F238E27FC236}">
                <a16:creationId xmlns="" xmlns:a16="http://schemas.microsoft.com/office/drawing/2014/main" id="{115F94CB-B39B-449E-839F-2C99EFB1F11C}"/>
              </a:ext>
            </a:extLst>
          </p:cNvPr>
          <p:cNvSpPr txBox="1"/>
          <p:nvPr/>
        </p:nvSpPr>
        <p:spPr>
          <a:xfrm>
            <a:off x="87757" y="251356"/>
            <a:ext cx="45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A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="" xmlns:a16="http://schemas.microsoft.com/office/drawing/2014/main" id="{115F94CB-B39B-449E-839F-2C99EFB1F11C}"/>
              </a:ext>
            </a:extLst>
          </p:cNvPr>
          <p:cNvSpPr txBox="1"/>
          <p:nvPr/>
        </p:nvSpPr>
        <p:spPr>
          <a:xfrm>
            <a:off x="4912293" y="251356"/>
            <a:ext cx="45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B</a:t>
            </a:r>
          </a:p>
        </p:txBody>
      </p:sp>
      <p:cxnSp>
        <p:nvCxnSpPr>
          <p:cNvPr id="7" name="Gerade Verbindung 6"/>
          <p:cNvCxnSpPr/>
          <p:nvPr/>
        </p:nvCxnSpPr>
        <p:spPr>
          <a:xfrm flipV="1">
            <a:off x="6156176" y="1052736"/>
            <a:ext cx="0" cy="115212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 Verbindung 9"/>
          <p:cNvCxnSpPr/>
          <p:nvPr/>
        </p:nvCxnSpPr>
        <p:spPr>
          <a:xfrm flipH="1">
            <a:off x="6156176" y="1052736"/>
            <a:ext cx="1800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 Verbindung 13"/>
          <p:cNvCxnSpPr/>
          <p:nvPr/>
        </p:nvCxnSpPr>
        <p:spPr>
          <a:xfrm flipH="1">
            <a:off x="6156176" y="1250288"/>
            <a:ext cx="57606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feld 12"/>
          <p:cNvSpPr txBox="1"/>
          <p:nvPr/>
        </p:nvSpPr>
        <p:spPr>
          <a:xfrm>
            <a:off x="6588224" y="827420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/>
              <a:t>*</a:t>
            </a:r>
            <a:endParaRPr lang="en-GB" dirty="0"/>
          </a:p>
        </p:txBody>
      </p:sp>
      <p:sp>
        <p:nvSpPr>
          <p:cNvPr id="17" name="Textfeld 16"/>
          <p:cNvSpPr txBox="1"/>
          <p:nvPr/>
        </p:nvSpPr>
        <p:spPr>
          <a:xfrm>
            <a:off x="5940152" y="1026852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*</a:t>
            </a:r>
            <a:endParaRPr lang="en-GB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757" y="397371"/>
            <a:ext cx="4541837" cy="38957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Rechteck 11"/>
          <p:cNvSpPr/>
          <p:nvPr/>
        </p:nvSpPr>
        <p:spPr>
          <a:xfrm>
            <a:off x="71992" y="5720769"/>
            <a:ext cx="8964503" cy="7591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MP-9-mediated a</a:t>
            </a:r>
            <a:r>
              <a:rPr lang="en-GB" sz="1100" b="1" dirty="0" err="1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ctivation</a:t>
            </a:r>
            <a:r>
              <a:rPr lang="en-GB" sz="1100" b="1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 of the Smad1-pathway is not altered by LPS in </a:t>
            </a:r>
            <a:r>
              <a:rPr lang="en-GB" sz="1100" b="1" dirty="0" err="1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hLSEC</a:t>
            </a:r>
            <a:r>
              <a:rPr lang="en-GB" sz="1100" b="1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. </a:t>
            </a:r>
            <a:r>
              <a:rPr lang="en-GB" sz="1100" dirty="0">
                <a:solidFill>
                  <a:srgbClr val="000000"/>
                </a:solidFill>
                <a:latin typeface="Times New Roman"/>
                <a:ea typeface="Times New Roman"/>
              </a:rPr>
              <a:t>(A) Human LSEC were pre-cultured with or without BMP-9 (5 ng/ml) for 24h followed by addition of LPS (100 ng/ml) for another 24h as indicated</a:t>
            </a:r>
            <a:r>
              <a:rPr lang="en-GB" sz="1100" dirty="0" smtClean="0">
                <a:solidFill>
                  <a:srgbClr val="000000"/>
                </a:solidFill>
                <a:latin typeface="Times New Roman"/>
                <a:ea typeface="Times New Roman"/>
              </a:rPr>
              <a:t>. Protein lysates </a:t>
            </a:r>
            <a:r>
              <a:rPr lang="en-GB" sz="1100" dirty="0">
                <a:solidFill>
                  <a:srgbClr val="000000"/>
                </a:solidFill>
                <a:latin typeface="Times New Roman"/>
                <a:ea typeface="Times New Roman"/>
              </a:rPr>
              <a:t>were subjected to Western blot </a:t>
            </a:r>
            <a:r>
              <a:rPr lang="en-GB" sz="1100" dirty="0" smtClean="0">
                <a:solidFill>
                  <a:srgbClr val="000000"/>
                </a:solidFill>
                <a:latin typeface="Times New Roman"/>
                <a:ea typeface="Times New Roman"/>
              </a:rPr>
              <a:t>analysis and activation of the Smad1 pathway was determined. (B) Expression </a:t>
            </a:r>
            <a:r>
              <a:rPr lang="en-GB" sz="1100" dirty="0">
                <a:solidFill>
                  <a:srgbClr val="000000"/>
                </a:solidFill>
                <a:latin typeface="Times New Roman"/>
                <a:ea typeface="Times New Roman"/>
              </a:rPr>
              <a:t>levels of </a:t>
            </a:r>
            <a:r>
              <a:rPr lang="en-GB" sz="1100" dirty="0" smtClean="0">
                <a:solidFill>
                  <a:srgbClr val="000000"/>
                </a:solidFill>
                <a:latin typeface="Times New Roman"/>
                <a:ea typeface="Times New Roman"/>
              </a:rPr>
              <a:t>the Smad1-pathway target gene Id1 were determined </a:t>
            </a:r>
            <a:r>
              <a:rPr lang="en-GB" sz="1100" dirty="0">
                <a:solidFill>
                  <a:srgbClr val="000000"/>
                </a:solidFill>
                <a:latin typeface="Times New Roman"/>
                <a:ea typeface="Times New Roman"/>
              </a:rPr>
              <a:t>by </a:t>
            </a:r>
            <a:r>
              <a:rPr lang="en-GB" sz="1100" dirty="0" smtClean="0">
                <a:solidFill>
                  <a:srgbClr val="000000"/>
                </a:solidFill>
                <a:latin typeface="Times New Roman"/>
                <a:ea typeface="Times New Roman"/>
              </a:rPr>
              <a:t>RT-qPCR as described for Fig. 3.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9085324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5</Words>
  <Application>Microsoft Office PowerPoint</Application>
  <PresentationFormat>Bildschirmpräsentation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-heidelberg.d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reitkopf, Katja</dc:creator>
  <cp:lastModifiedBy>Breitkopf, Katja</cp:lastModifiedBy>
  <cp:revision>6</cp:revision>
  <cp:lastPrinted>2020-02-24T13:14:00Z</cp:lastPrinted>
  <dcterms:created xsi:type="dcterms:W3CDTF">2019-10-07T12:19:05Z</dcterms:created>
  <dcterms:modified xsi:type="dcterms:W3CDTF">2020-02-24T13:14:00Z</dcterms:modified>
</cp:coreProperties>
</file>